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2D8B0F3A-B092-448C-BCBE-717453BDEAD7}" v="2" dt="2024-07-17T10:57:20.453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339" autoAdjust="0"/>
    <p:restoredTop sz="94660"/>
  </p:normalViewPr>
  <p:slideViewPr>
    <p:cSldViewPr snapToGrid="0">
      <p:cViewPr varScale="1">
        <p:scale>
          <a:sx n="82" d="100"/>
          <a:sy n="82" d="100"/>
        </p:scale>
        <p:origin x="490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aycock, Joseph" userId="c4bfcbf4-3ccc-440e-b317-559baf184f0d" providerId="ADAL" clId="{2D8B0F3A-B092-448C-BCBE-717453BDEAD7}"/>
    <pc:docChg chg="undo redo custSel delSld modSld">
      <pc:chgData name="Laycock, Joseph" userId="c4bfcbf4-3ccc-440e-b317-559baf184f0d" providerId="ADAL" clId="{2D8B0F3A-B092-448C-BCBE-717453BDEAD7}" dt="2024-07-17T10:57:37.923" v="76" actId="1038"/>
      <pc:docMkLst>
        <pc:docMk/>
      </pc:docMkLst>
      <pc:sldChg chg="addSp delSp modSp mod">
        <pc:chgData name="Laycock, Joseph" userId="c4bfcbf4-3ccc-440e-b317-559baf184f0d" providerId="ADAL" clId="{2D8B0F3A-B092-448C-BCBE-717453BDEAD7}" dt="2024-07-17T10:57:37.923" v="76" actId="1038"/>
        <pc:sldMkLst>
          <pc:docMk/>
          <pc:sldMk cId="2867428870" sldId="268"/>
        </pc:sldMkLst>
        <pc:spChg chg="del">
          <ac:chgData name="Laycock, Joseph" userId="c4bfcbf4-3ccc-440e-b317-559baf184f0d" providerId="ADAL" clId="{2D8B0F3A-B092-448C-BCBE-717453BDEAD7}" dt="2024-07-17T10:56:09.668" v="46" actId="478"/>
          <ac:spMkLst>
            <pc:docMk/>
            <pc:sldMk cId="2867428870" sldId="268"/>
            <ac:spMk id="2" creationId="{F36A2367-4C1F-DF61-526E-3B5E7804B265}"/>
          </ac:spMkLst>
        </pc:spChg>
        <pc:spChg chg="add mod">
          <ac:chgData name="Laycock, Joseph" userId="c4bfcbf4-3ccc-440e-b317-559baf184f0d" providerId="ADAL" clId="{2D8B0F3A-B092-448C-BCBE-717453BDEAD7}" dt="2024-07-17T10:56:41.977" v="51"/>
          <ac:spMkLst>
            <pc:docMk/>
            <pc:sldMk cId="2867428870" sldId="268"/>
            <ac:spMk id="3" creationId="{AAD6C26F-B643-CCAE-59FF-AD598B6D6562}"/>
          </ac:spMkLst>
        </pc:spChg>
        <pc:spChg chg="add mod">
          <ac:chgData name="Laycock, Joseph" userId="c4bfcbf4-3ccc-440e-b317-559baf184f0d" providerId="ADAL" clId="{2D8B0F3A-B092-448C-BCBE-717453BDEAD7}" dt="2024-07-17T10:56:41.977" v="51"/>
          <ac:spMkLst>
            <pc:docMk/>
            <pc:sldMk cId="2867428870" sldId="268"/>
            <ac:spMk id="4" creationId="{E5A414E1-34CA-F818-5E31-2D0EB4A7C5C9}"/>
          </ac:spMkLst>
        </pc:spChg>
        <pc:spChg chg="add mod">
          <ac:chgData name="Laycock, Joseph" userId="c4bfcbf4-3ccc-440e-b317-559baf184f0d" providerId="ADAL" clId="{2D8B0F3A-B092-448C-BCBE-717453BDEAD7}" dt="2024-07-17T10:56:41.977" v="51"/>
          <ac:spMkLst>
            <pc:docMk/>
            <pc:sldMk cId="2867428870" sldId="268"/>
            <ac:spMk id="5" creationId="{8074B33E-2F20-09A4-7913-12D8DDB457E0}"/>
          </ac:spMkLst>
        </pc:spChg>
        <pc:spChg chg="mod">
          <ac:chgData name="Laycock, Joseph" userId="c4bfcbf4-3ccc-440e-b317-559baf184f0d" providerId="ADAL" clId="{2D8B0F3A-B092-448C-BCBE-717453BDEAD7}" dt="2024-07-17T10:56:41.977" v="51"/>
          <ac:spMkLst>
            <pc:docMk/>
            <pc:sldMk cId="2867428870" sldId="268"/>
            <ac:spMk id="8" creationId="{8C52C898-C44E-FEE0-0F6E-B88AC9BA518D}"/>
          </ac:spMkLst>
        </pc:spChg>
        <pc:spChg chg="add mod">
          <ac:chgData name="Laycock, Joseph" userId="c4bfcbf4-3ccc-440e-b317-559baf184f0d" providerId="ADAL" clId="{2D8B0F3A-B092-448C-BCBE-717453BDEAD7}" dt="2024-07-17T10:56:41.977" v="51"/>
          <ac:spMkLst>
            <pc:docMk/>
            <pc:sldMk cId="2867428870" sldId="268"/>
            <ac:spMk id="9" creationId="{1A6F926A-3B51-38BB-CC28-440EA436CA60}"/>
          </ac:spMkLst>
        </pc:spChg>
        <pc:spChg chg="add mod">
          <ac:chgData name="Laycock, Joseph" userId="c4bfcbf4-3ccc-440e-b317-559baf184f0d" providerId="ADAL" clId="{2D8B0F3A-B092-448C-BCBE-717453BDEAD7}" dt="2024-07-17T10:56:41.977" v="51"/>
          <ac:spMkLst>
            <pc:docMk/>
            <pc:sldMk cId="2867428870" sldId="268"/>
            <ac:spMk id="14" creationId="{8C766A60-D5A6-DC84-9034-44AEC648A57E}"/>
          </ac:spMkLst>
        </pc:spChg>
        <pc:spChg chg="add mod">
          <ac:chgData name="Laycock, Joseph" userId="c4bfcbf4-3ccc-440e-b317-559baf184f0d" providerId="ADAL" clId="{2D8B0F3A-B092-448C-BCBE-717453BDEAD7}" dt="2024-07-17T10:57:12.558" v="67" actId="20577"/>
          <ac:spMkLst>
            <pc:docMk/>
            <pc:sldMk cId="2867428870" sldId="268"/>
            <ac:spMk id="16" creationId="{D2A24C84-B82E-8EFD-A389-AFA70F4578CF}"/>
          </ac:spMkLst>
        </pc:spChg>
        <pc:spChg chg="add mod">
          <ac:chgData name="Laycock, Joseph" userId="c4bfcbf4-3ccc-440e-b317-559baf184f0d" providerId="ADAL" clId="{2D8B0F3A-B092-448C-BCBE-717453BDEAD7}" dt="2024-07-17T10:56:41.977" v="51"/>
          <ac:spMkLst>
            <pc:docMk/>
            <pc:sldMk cId="2867428870" sldId="268"/>
            <ac:spMk id="17" creationId="{D23BF415-9E21-BF56-6FBC-4073E04109A9}"/>
          </ac:spMkLst>
        </pc:spChg>
        <pc:spChg chg="add mod">
          <ac:chgData name="Laycock, Joseph" userId="c4bfcbf4-3ccc-440e-b317-559baf184f0d" providerId="ADAL" clId="{2D8B0F3A-B092-448C-BCBE-717453BDEAD7}" dt="2024-07-17T10:56:41.977" v="51"/>
          <ac:spMkLst>
            <pc:docMk/>
            <pc:sldMk cId="2867428870" sldId="268"/>
            <ac:spMk id="18" creationId="{19B18D98-FD43-9EFF-8240-B2C754B7E66C}"/>
          </ac:spMkLst>
        </pc:spChg>
        <pc:spChg chg="add mod">
          <ac:chgData name="Laycock, Joseph" userId="c4bfcbf4-3ccc-440e-b317-559baf184f0d" providerId="ADAL" clId="{2D8B0F3A-B092-448C-BCBE-717453BDEAD7}" dt="2024-07-17T10:56:41.977" v="51"/>
          <ac:spMkLst>
            <pc:docMk/>
            <pc:sldMk cId="2867428870" sldId="268"/>
            <ac:spMk id="19" creationId="{D8EF2481-4387-7AA2-B43A-EBF97A949A27}"/>
          </ac:spMkLst>
        </pc:spChg>
        <pc:spChg chg="mod">
          <ac:chgData name="Laycock, Joseph" userId="c4bfcbf4-3ccc-440e-b317-559baf184f0d" providerId="ADAL" clId="{2D8B0F3A-B092-448C-BCBE-717453BDEAD7}" dt="2024-07-17T10:54:29.132" v="11" actId="27636"/>
          <ac:spMkLst>
            <pc:docMk/>
            <pc:sldMk cId="2867428870" sldId="268"/>
            <ac:spMk id="24" creationId="{00000000-0000-0000-0000-000000000000}"/>
          </ac:spMkLst>
        </pc:spChg>
        <pc:spChg chg="mod">
          <ac:chgData name="Laycock, Joseph" userId="c4bfcbf4-3ccc-440e-b317-559baf184f0d" providerId="ADAL" clId="{2D8B0F3A-B092-448C-BCBE-717453BDEAD7}" dt="2024-07-17T10:57:37.923" v="76" actId="1038"/>
          <ac:spMkLst>
            <pc:docMk/>
            <pc:sldMk cId="2867428870" sldId="268"/>
            <ac:spMk id="25" creationId="{00000000-0000-0000-0000-000000000000}"/>
          </ac:spMkLst>
        </pc:spChg>
        <pc:spChg chg="del">
          <ac:chgData name="Laycock, Joseph" userId="c4bfcbf4-3ccc-440e-b317-559baf184f0d" providerId="ADAL" clId="{2D8B0F3A-B092-448C-BCBE-717453BDEAD7}" dt="2024-07-17T10:56:09.668" v="46" actId="478"/>
          <ac:spMkLst>
            <pc:docMk/>
            <pc:sldMk cId="2867428870" sldId="268"/>
            <ac:spMk id="26" creationId="{00000000-0000-0000-0000-000000000000}"/>
          </ac:spMkLst>
        </pc:spChg>
        <pc:spChg chg="mod">
          <ac:chgData name="Laycock, Joseph" userId="c4bfcbf4-3ccc-440e-b317-559baf184f0d" providerId="ADAL" clId="{2D8B0F3A-B092-448C-BCBE-717453BDEAD7}" dt="2024-07-17T10:55:33.630" v="40" actId="20577"/>
          <ac:spMkLst>
            <pc:docMk/>
            <pc:sldMk cId="2867428870" sldId="268"/>
            <ac:spMk id="27" creationId="{00000000-0000-0000-0000-000000000000}"/>
          </ac:spMkLst>
        </pc:spChg>
        <pc:spChg chg="mod">
          <ac:chgData name="Laycock, Joseph" userId="c4bfcbf4-3ccc-440e-b317-559baf184f0d" providerId="ADAL" clId="{2D8B0F3A-B092-448C-BCBE-717453BDEAD7}" dt="2024-07-17T10:57:32.533" v="73" actId="1035"/>
          <ac:spMkLst>
            <pc:docMk/>
            <pc:sldMk cId="2867428870" sldId="268"/>
            <ac:spMk id="28" creationId="{00000000-0000-0000-0000-000000000000}"/>
          </ac:spMkLst>
        </pc:spChg>
        <pc:spChg chg="mod">
          <ac:chgData name="Laycock, Joseph" userId="c4bfcbf4-3ccc-440e-b317-559baf184f0d" providerId="ADAL" clId="{2D8B0F3A-B092-448C-BCBE-717453BDEAD7}" dt="2024-07-17T10:56:41.977" v="51"/>
          <ac:spMkLst>
            <pc:docMk/>
            <pc:sldMk cId="2867428870" sldId="268"/>
            <ac:spMk id="29" creationId="{6EBFD725-0F45-1390-870F-EC11F4DA0392}"/>
          </ac:spMkLst>
        </pc:spChg>
        <pc:spChg chg="mod">
          <ac:chgData name="Laycock, Joseph" userId="c4bfcbf4-3ccc-440e-b317-559baf184f0d" providerId="ADAL" clId="{2D8B0F3A-B092-448C-BCBE-717453BDEAD7}" dt="2024-07-17T10:56:41.977" v="51"/>
          <ac:spMkLst>
            <pc:docMk/>
            <pc:sldMk cId="2867428870" sldId="268"/>
            <ac:spMk id="30" creationId="{8EE3F690-BF98-3CBA-639A-86A97414EA88}"/>
          </ac:spMkLst>
        </pc:spChg>
        <pc:spChg chg="mod">
          <ac:chgData name="Laycock, Joseph" userId="c4bfcbf4-3ccc-440e-b317-559baf184f0d" providerId="ADAL" clId="{2D8B0F3A-B092-448C-BCBE-717453BDEAD7}" dt="2024-07-17T10:56:41.977" v="51"/>
          <ac:spMkLst>
            <pc:docMk/>
            <pc:sldMk cId="2867428870" sldId="268"/>
            <ac:spMk id="31" creationId="{5DECD69D-9E31-277B-E1DA-972D0A0A1037}"/>
          </ac:spMkLst>
        </pc:spChg>
        <pc:spChg chg="mod">
          <ac:chgData name="Laycock, Joseph" userId="c4bfcbf4-3ccc-440e-b317-559baf184f0d" providerId="ADAL" clId="{2D8B0F3A-B092-448C-BCBE-717453BDEAD7}" dt="2024-07-17T10:56:41.977" v="51"/>
          <ac:spMkLst>
            <pc:docMk/>
            <pc:sldMk cId="2867428870" sldId="268"/>
            <ac:spMk id="33" creationId="{B6E9F60C-4A08-5CB0-9919-D4FA68A1D2A8}"/>
          </ac:spMkLst>
        </pc:spChg>
        <pc:grpChg chg="add mod">
          <ac:chgData name="Laycock, Joseph" userId="c4bfcbf4-3ccc-440e-b317-559baf184f0d" providerId="ADAL" clId="{2D8B0F3A-B092-448C-BCBE-717453BDEAD7}" dt="2024-07-17T10:56:41.977" v="51"/>
          <ac:grpSpMkLst>
            <pc:docMk/>
            <pc:sldMk cId="2867428870" sldId="268"/>
            <ac:grpSpMk id="6" creationId="{33DAFCF1-A4A4-96EB-D18F-68229376C90E}"/>
          </ac:grpSpMkLst>
        </pc:grpChg>
        <pc:grpChg chg="add mod">
          <ac:chgData name="Laycock, Joseph" userId="c4bfcbf4-3ccc-440e-b317-559baf184f0d" providerId="ADAL" clId="{2D8B0F3A-B092-448C-BCBE-717453BDEAD7}" dt="2024-07-17T10:56:41.977" v="51"/>
          <ac:grpSpMkLst>
            <pc:docMk/>
            <pc:sldMk cId="2867428870" sldId="268"/>
            <ac:grpSpMk id="10" creationId="{54BE7682-88EA-F175-EE93-8A679443BB4A}"/>
          </ac:grpSpMkLst>
        </pc:grpChg>
        <pc:grpChg chg="add mod">
          <ac:chgData name="Laycock, Joseph" userId="c4bfcbf4-3ccc-440e-b317-559baf184f0d" providerId="ADAL" clId="{2D8B0F3A-B092-448C-BCBE-717453BDEAD7}" dt="2024-07-17T10:56:41.977" v="51"/>
          <ac:grpSpMkLst>
            <pc:docMk/>
            <pc:sldMk cId="2867428870" sldId="268"/>
            <ac:grpSpMk id="20" creationId="{010AC855-2E64-1763-D761-DF5C0E33B8EF}"/>
          </ac:grpSpMkLst>
        </pc:grpChg>
        <pc:picChg chg="mod">
          <ac:chgData name="Laycock, Joseph" userId="c4bfcbf4-3ccc-440e-b317-559baf184f0d" providerId="ADAL" clId="{2D8B0F3A-B092-448C-BCBE-717453BDEAD7}" dt="2024-07-17T10:56:41.977" v="51"/>
          <ac:picMkLst>
            <pc:docMk/>
            <pc:sldMk cId="2867428870" sldId="268"/>
            <ac:picMk id="7" creationId="{396A4F9B-E435-2FFD-2089-A93CD0CF20D4}"/>
          </ac:picMkLst>
        </pc:picChg>
        <pc:picChg chg="mod">
          <ac:chgData name="Laycock, Joseph" userId="c4bfcbf4-3ccc-440e-b317-559baf184f0d" providerId="ADAL" clId="{2D8B0F3A-B092-448C-BCBE-717453BDEAD7}" dt="2024-07-17T10:56:41.977" v="51"/>
          <ac:picMkLst>
            <pc:docMk/>
            <pc:sldMk cId="2867428870" sldId="268"/>
            <ac:picMk id="11" creationId="{37D1DBE8-8E07-1877-C319-00315B2807E6}"/>
          </ac:picMkLst>
        </pc:picChg>
        <pc:picChg chg="mod">
          <ac:chgData name="Laycock, Joseph" userId="c4bfcbf4-3ccc-440e-b317-559baf184f0d" providerId="ADAL" clId="{2D8B0F3A-B092-448C-BCBE-717453BDEAD7}" dt="2024-07-17T10:56:41.977" v="51"/>
          <ac:picMkLst>
            <pc:docMk/>
            <pc:sldMk cId="2867428870" sldId="268"/>
            <ac:picMk id="12" creationId="{8C4A5B67-16F5-F065-3110-E380D90F5FB3}"/>
          </ac:picMkLst>
        </pc:picChg>
        <pc:picChg chg="add mod">
          <ac:chgData name="Laycock, Joseph" userId="c4bfcbf4-3ccc-440e-b317-559baf184f0d" providerId="ADAL" clId="{2D8B0F3A-B092-448C-BCBE-717453BDEAD7}" dt="2024-07-17T10:56:41.977" v="51"/>
          <ac:picMkLst>
            <pc:docMk/>
            <pc:sldMk cId="2867428870" sldId="268"/>
            <ac:picMk id="15" creationId="{D7203274-0280-7C3F-E4B4-2CC2C443F4E1}"/>
          </ac:picMkLst>
        </pc:picChg>
        <pc:picChg chg="mod">
          <ac:chgData name="Laycock, Joseph" userId="c4bfcbf4-3ccc-440e-b317-559baf184f0d" providerId="ADAL" clId="{2D8B0F3A-B092-448C-BCBE-717453BDEAD7}" dt="2024-07-17T10:56:41.977" v="51"/>
          <ac:picMkLst>
            <pc:docMk/>
            <pc:sldMk cId="2867428870" sldId="268"/>
            <ac:picMk id="21" creationId="{5CB3AA2F-DD32-7CE8-0C8B-1B68D27B6E43}"/>
          </ac:picMkLst>
        </pc:picChg>
        <pc:picChg chg="mod">
          <ac:chgData name="Laycock, Joseph" userId="c4bfcbf4-3ccc-440e-b317-559baf184f0d" providerId="ADAL" clId="{2D8B0F3A-B092-448C-BCBE-717453BDEAD7}" dt="2024-07-17T10:56:41.977" v="51"/>
          <ac:picMkLst>
            <pc:docMk/>
            <pc:sldMk cId="2867428870" sldId="268"/>
            <ac:picMk id="22" creationId="{A664DD38-C019-49A8-83DF-C3B4AEB9FADA}"/>
          </ac:picMkLst>
        </pc:picChg>
        <pc:picChg chg="mod">
          <ac:chgData name="Laycock, Joseph" userId="c4bfcbf4-3ccc-440e-b317-559baf184f0d" providerId="ADAL" clId="{2D8B0F3A-B092-448C-BCBE-717453BDEAD7}" dt="2024-07-17T10:56:41.977" v="51"/>
          <ac:picMkLst>
            <pc:docMk/>
            <pc:sldMk cId="2867428870" sldId="268"/>
            <ac:picMk id="23" creationId="{26B1390D-77F0-5261-95C8-C70A3D1EA276}"/>
          </ac:picMkLst>
        </pc:picChg>
        <pc:picChg chg="mod">
          <ac:chgData name="Laycock, Joseph" userId="c4bfcbf4-3ccc-440e-b317-559baf184f0d" providerId="ADAL" clId="{2D8B0F3A-B092-448C-BCBE-717453BDEAD7}" dt="2024-07-17T10:56:41.977" v="51"/>
          <ac:picMkLst>
            <pc:docMk/>
            <pc:sldMk cId="2867428870" sldId="268"/>
            <ac:picMk id="32" creationId="{1F280006-3F5A-5871-A5CC-10233442D707}"/>
          </ac:picMkLst>
        </pc:picChg>
        <pc:picChg chg="add mod">
          <ac:chgData name="Laycock, Joseph" userId="c4bfcbf4-3ccc-440e-b317-559baf184f0d" providerId="ADAL" clId="{2D8B0F3A-B092-448C-BCBE-717453BDEAD7}" dt="2024-07-17T10:56:41.977" v="51"/>
          <ac:picMkLst>
            <pc:docMk/>
            <pc:sldMk cId="2867428870" sldId="268"/>
            <ac:picMk id="34" creationId="{00195409-A70E-E5BC-4A64-AA23C98F8D71}"/>
          </ac:picMkLst>
        </pc:picChg>
        <pc:picChg chg="add mod">
          <ac:chgData name="Laycock, Joseph" userId="c4bfcbf4-3ccc-440e-b317-559baf184f0d" providerId="ADAL" clId="{2D8B0F3A-B092-448C-BCBE-717453BDEAD7}" dt="2024-07-17T10:56:41.977" v="51"/>
          <ac:picMkLst>
            <pc:docMk/>
            <pc:sldMk cId="2867428870" sldId="268"/>
            <ac:picMk id="35" creationId="{0FCEA433-ADD5-B76D-DA10-C46A37C9E0B7}"/>
          </ac:picMkLst>
        </pc:picChg>
        <pc:cxnChg chg="mod">
          <ac:chgData name="Laycock, Joseph" userId="c4bfcbf4-3ccc-440e-b317-559baf184f0d" providerId="ADAL" clId="{2D8B0F3A-B092-448C-BCBE-717453BDEAD7}" dt="2024-07-17T10:56:41.977" v="51"/>
          <ac:cxnSpMkLst>
            <pc:docMk/>
            <pc:sldMk cId="2867428870" sldId="268"/>
            <ac:cxnSpMk id="13" creationId="{BDFA5458-B879-4927-E389-7BA32C780BC5}"/>
          </ac:cxnSpMkLst>
        </pc:cxnChg>
      </pc:sldChg>
      <pc:sldChg chg="del">
        <pc:chgData name="Laycock, Joseph" userId="c4bfcbf4-3ccc-440e-b317-559baf184f0d" providerId="ADAL" clId="{2D8B0F3A-B092-448C-BCBE-717453BDEAD7}" dt="2024-07-17T10:54:14.871" v="0" actId="47"/>
        <pc:sldMkLst>
          <pc:docMk/>
          <pc:sldMk cId="808818969" sldId="269"/>
        </pc:sldMkLst>
      </pc:sldChg>
      <pc:sldChg chg="del">
        <pc:chgData name="Laycock, Joseph" userId="c4bfcbf4-3ccc-440e-b317-559baf184f0d" providerId="ADAL" clId="{2D8B0F3A-B092-448C-BCBE-717453BDEAD7}" dt="2024-07-17T10:54:17.007" v="2" actId="47"/>
        <pc:sldMkLst>
          <pc:docMk/>
          <pc:sldMk cId="3242791597" sldId="270"/>
        </pc:sldMkLst>
      </pc:sldChg>
      <pc:sldChg chg="del">
        <pc:chgData name="Laycock, Joseph" userId="c4bfcbf4-3ccc-440e-b317-559baf184f0d" providerId="ADAL" clId="{2D8B0F3A-B092-448C-BCBE-717453BDEAD7}" dt="2024-07-17T10:54:16.689" v="1" actId="47"/>
        <pc:sldMkLst>
          <pc:docMk/>
          <pc:sldMk cId="1120905658" sldId="271"/>
        </pc:sldMkLst>
      </pc:sldChg>
      <pc:sldChg chg="del">
        <pc:chgData name="Laycock, Joseph" userId="c4bfcbf4-3ccc-440e-b317-559baf184f0d" providerId="ADAL" clId="{2D8B0F3A-B092-448C-BCBE-717453BDEAD7}" dt="2024-07-17T10:54:17.740" v="5" actId="47"/>
        <pc:sldMkLst>
          <pc:docMk/>
          <pc:sldMk cId="4048924459" sldId="272"/>
        </pc:sldMkLst>
      </pc:sldChg>
      <pc:sldChg chg="del">
        <pc:chgData name="Laycock, Joseph" userId="c4bfcbf4-3ccc-440e-b317-559baf184f0d" providerId="ADAL" clId="{2D8B0F3A-B092-448C-BCBE-717453BDEAD7}" dt="2024-07-17T10:54:17.291" v="4" actId="47"/>
        <pc:sldMkLst>
          <pc:docMk/>
          <pc:sldMk cId="2977807225" sldId="273"/>
        </pc:sldMkLst>
      </pc:sldChg>
      <pc:sldChg chg="del">
        <pc:chgData name="Laycock, Joseph" userId="c4bfcbf4-3ccc-440e-b317-559baf184f0d" providerId="ADAL" clId="{2D8B0F3A-B092-448C-BCBE-717453BDEAD7}" dt="2024-07-17T10:54:17.156" v="3" actId="47"/>
        <pc:sldMkLst>
          <pc:docMk/>
          <pc:sldMk cId="1305034209" sldId="274"/>
        </pc:sldMkLst>
      </pc:sldChg>
      <pc:sldMasterChg chg="delSldLayout">
        <pc:chgData name="Laycock, Joseph" userId="c4bfcbf4-3ccc-440e-b317-559baf184f0d" providerId="ADAL" clId="{2D8B0F3A-B092-448C-BCBE-717453BDEAD7}" dt="2024-07-17T10:54:17.007" v="2" actId="47"/>
        <pc:sldMasterMkLst>
          <pc:docMk/>
          <pc:sldMasterMk cId="690031264" sldId="2147483648"/>
        </pc:sldMasterMkLst>
        <pc:sldLayoutChg chg="del">
          <pc:chgData name="Laycock, Joseph" userId="c4bfcbf4-3ccc-440e-b317-559baf184f0d" providerId="ADAL" clId="{2D8B0F3A-B092-448C-BCBE-717453BDEAD7}" dt="2024-07-17T10:54:17.007" v="2" actId="47"/>
          <pc:sldLayoutMkLst>
            <pc:docMk/>
            <pc:sldMasterMk cId="690031264" sldId="2147483648"/>
            <pc:sldLayoutMk cId="2266668884" sldId="2147483651"/>
          </pc:sldLayoutMkLst>
        </pc:sldLayoutChg>
      </pc:sldMaster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7/07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13" Type="http://schemas.openxmlformats.org/officeDocument/2006/relationships/image" Target="../media/image13.svg"/><Relationship Id="rId18" Type="http://schemas.openxmlformats.org/officeDocument/2006/relationships/image" Target="../media/image18.png"/><Relationship Id="rId3" Type="http://schemas.openxmlformats.org/officeDocument/2006/relationships/image" Target="../media/image3.svg"/><Relationship Id="rId7" Type="http://schemas.openxmlformats.org/officeDocument/2006/relationships/image" Target="../media/image7.jpeg"/><Relationship Id="rId12" Type="http://schemas.openxmlformats.org/officeDocument/2006/relationships/image" Target="../media/image12.png"/><Relationship Id="rId17" Type="http://schemas.openxmlformats.org/officeDocument/2006/relationships/image" Target="../media/image17.svg"/><Relationship Id="rId2" Type="http://schemas.openxmlformats.org/officeDocument/2006/relationships/image" Target="../media/image2.png"/><Relationship Id="rId16" Type="http://schemas.openxmlformats.org/officeDocument/2006/relationships/image" Target="../media/image16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6.png"/><Relationship Id="rId11" Type="http://schemas.openxmlformats.org/officeDocument/2006/relationships/image" Target="../media/image11.svg"/><Relationship Id="rId5" Type="http://schemas.openxmlformats.org/officeDocument/2006/relationships/image" Target="../media/image5.svg"/><Relationship Id="rId15" Type="http://schemas.openxmlformats.org/officeDocument/2006/relationships/image" Target="../media/image15.svg"/><Relationship Id="rId10" Type="http://schemas.openxmlformats.org/officeDocument/2006/relationships/image" Target="../media/image10.png"/><Relationship Id="rId19" Type="http://schemas.openxmlformats.org/officeDocument/2006/relationships/image" Target="../media/image19.svg"/><Relationship Id="rId4" Type="http://schemas.openxmlformats.org/officeDocument/2006/relationships/image" Target="../media/image4.png"/><Relationship Id="rId9" Type="http://schemas.openxmlformats.org/officeDocument/2006/relationships/image" Target="../media/image9.svg"/><Relationship Id="rId14" Type="http://schemas.openxmlformats.org/officeDocument/2006/relationships/image" Target="../media/image1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800" dirty="0">
                <a:solidFill>
                  <a:schemeClr val="bg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The spectrum of co-existing disease in children with established kidney failure using registry and linked electronic health record data</a:t>
            </a:r>
            <a:endParaRPr lang="en-GB" sz="2800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208175" y="1068456"/>
            <a:ext cx="11838369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solidFill>
                  <a:schemeClr val="bg1"/>
                </a:solidFill>
              </a:rPr>
              <a:t>AIM</a:t>
            </a:r>
            <a:r>
              <a:rPr lang="en-GB" sz="1600" dirty="0">
                <a:solidFill>
                  <a:schemeClr val="bg1"/>
                </a:solidFill>
              </a:rPr>
              <a:t>: To compare co-existing disease codes in the </a:t>
            </a:r>
            <a:r>
              <a:rPr lang="en-GB" sz="1600" dirty="0" err="1">
                <a:solidFill>
                  <a:schemeClr val="bg1"/>
                </a:solidFill>
              </a:rPr>
              <a:t>electroanic</a:t>
            </a:r>
            <a:r>
              <a:rPr lang="en-GB" sz="1600" dirty="0">
                <a:solidFill>
                  <a:schemeClr val="bg1"/>
                </a:solidFill>
              </a:rPr>
              <a:t> health record with UK Renal Registry data for children with kidney failure in England and Wales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Plumb et al. 2024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00510"/>
            <a:ext cx="7141846" cy="15542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GB" sz="1800" dirty="0">
                <a:solidFill>
                  <a:schemeClr val="bg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Electronic health records offer a non-selective overview of co-existing disease, particularly for conditions with a high burden of hospital care. For other variables that may influence kidney failure care, registries remain important sources for data capture. </a:t>
            </a:r>
            <a:endParaRPr lang="en-GB" sz="1800" dirty="0">
              <a:solidFill>
                <a:schemeClr val="bg1"/>
              </a:solidFill>
            </a:endParaRPr>
          </a:p>
          <a:p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AAD6C26F-B643-CCAE-59FF-AD598B6D6562}"/>
              </a:ext>
            </a:extLst>
          </p:cNvPr>
          <p:cNvSpPr txBox="1"/>
          <p:nvPr/>
        </p:nvSpPr>
        <p:spPr>
          <a:xfrm>
            <a:off x="180182" y="1758951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4277"/>
                </a:solidFill>
              </a:rPr>
              <a:t>DESIGN</a:t>
            </a:r>
            <a:r>
              <a:rPr lang="en-GB" dirty="0">
                <a:solidFill>
                  <a:srgbClr val="004277"/>
                </a:solidFill>
              </a:rPr>
              <a:t>: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E5A414E1-34CA-F818-5E31-2D0EB4A7C5C9}"/>
              </a:ext>
            </a:extLst>
          </p:cNvPr>
          <p:cNvSpPr txBox="1"/>
          <p:nvPr/>
        </p:nvSpPr>
        <p:spPr>
          <a:xfrm>
            <a:off x="645295" y="3634778"/>
            <a:ext cx="311972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dirty="0">
                <a:solidFill>
                  <a:srgbClr val="00437A"/>
                </a:solidFill>
              </a:rPr>
              <a:t>Linkage to electronic health records</a:t>
            </a:r>
          </a:p>
          <a:p>
            <a:pPr algn="ctr"/>
            <a:r>
              <a:rPr lang="en-GB" sz="1100" dirty="0">
                <a:solidFill>
                  <a:srgbClr val="00437A"/>
                </a:solidFill>
              </a:rPr>
              <a:t>Hospital </a:t>
            </a:r>
            <a:r>
              <a:rPr lang="en-GB" sz="1100">
                <a:solidFill>
                  <a:srgbClr val="00437A"/>
                </a:solidFill>
              </a:rPr>
              <a:t>Episode Statistics (HES) </a:t>
            </a:r>
            <a:r>
              <a:rPr lang="en-GB" sz="1100" dirty="0">
                <a:solidFill>
                  <a:srgbClr val="00437A"/>
                </a:solidFill>
              </a:rPr>
              <a:t>&amp;</a:t>
            </a:r>
          </a:p>
          <a:p>
            <a:pPr algn="ctr"/>
            <a:r>
              <a:rPr lang="en-GB" sz="1100" dirty="0">
                <a:solidFill>
                  <a:srgbClr val="00437A"/>
                </a:solidFill>
              </a:rPr>
              <a:t>Patient Episode Database for Wales (PEDW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074B33E-2F20-09A4-7913-12D8DDB457E0}"/>
              </a:ext>
            </a:extLst>
          </p:cNvPr>
          <p:cNvSpPr txBox="1"/>
          <p:nvPr/>
        </p:nvSpPr>
        <p:spPr>
          <a:xfrm>
            <a:off x="180182" y="4281109"/>
            <a:ext cx="16784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spc="-5" dirty="0">
                <a:solidFill>
                  <a:srgbClr val="004277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O</a:t>
            </a:r>
            <a:r>
              <a:rPr lang="en-GB" b="1" spc="-5" dirty="0">
                <a:solidFill>
                  <a:srgbClr val="004277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UTCOMES:</a:t>
            </a:r>
            <a:endParaRPr lang="en-US" b="1" dirty="0">
              <a:solidFill>
                <a:srgbClr val="004277"/>
              </a:solidFill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id="{33DAFCF1-A4A4-96EB-D18F-68229376C90E}"/>
              </a:ext>
            </a:extLst>
          </p:cNvPr>
          <p:cNvGrpSpPr/>
          <p:nvPr/>
        </p:nvGrpSpPr>
        <p:grpSpPr>
          <a:xfrm>
            <a:off x="228014" y="2042594"/>
            <a:ext cx="4247295" cy="947643"/>
            <a:chOff x="228014" y="2042594"/>
            <a:chExt cx="4247295" cy="947643"/>
          </a:xfrm>
        </p:grpSpPr>
        <p:pic>
          <p:nvPicPr>
            <p:cNvPr id="7" name="Graphic 6" descr="Children with solid fill">
              <a:extLst>
                <a:ext uri="{FF2B5EF4-FFF2-40B4-BE49-F238E27FC236}">
                  <a16:creationId xmlns:a16="http://schemas.microsoft.com/office/drawing/2014/main" id="{396A4F9B-E435-2FFD-2089-A93CD0CF20D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96DAC541-7B7A-43D3-8B79-37D633B846F1}">
                  <asvg:svgBlip xmlns:asvg="http://schemas.microsoft.com/office/drawing/2016/SVG/main" r:embed="rId3"/>
                </a:ext>
              </a:extLst>
            </a:blip>
            <a:stretch>
              <a:fillRect/>
            </a:stretch>
          </p:blipFill>
          <p:spPr>
            <a:xfrm>
              <a:off x="228014" y="2042594"/>
              <a:ext cx="1015143" cy="947643"/>
            </a:xfrm>
            <a:prstGeom prst="rect">
              <a:avLst/>
            </a:prstGeom>
          </p:spPr>
        </p:pic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8C52C898-C44E-FEE0-0F6E-B88AC9BA518D}"/>
                </a:ext>
              </a:extLst>
            </p:cNvPr>
            <p:cNvSpPr txBox="1"/>
            <p:nvPr/>
          </p:nvSpPr>
          <p:spPr>
            <a:xfrm>
              <a:off x="1243157" y="2136640"/>
              <a:ext cx="3232152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400" dirty="0">
                  <a:solidFill>
                    <a:srgbClr val="00437A"/>
                  </a:solidFill>
                </a:rPr>
                <a:t>Children &lt;18 years receiving kidney replacement therapy (KRT) in England &amp; Wales</a:t>
              </a:r>
            </a:p>
          </p:txBody>
        </p:sp>
      </p:grpSp>
      <p:sp>
        <p:nvSpPr>
          <p:cNvPr id="9" name="TextBox 8">
            <a:extLst>
              <a:ext uri="{FF2B5EF4-FFF2-40B4-BE49-F238E27FC236}">
                <a16:creationId xmlns:a16="http://schemas.microsoft.com/office/drawing/2014/main" id="{1A6F926A-3B51-38BB-CC28-440EA436CA60}"/>
              </a:ext>
            </a:extLst>
          </p:cNvPr>
          <p:cNvSpPr txBox="1"/>
          <p:nvPr/>
        </p:nvSpPr>
        <p:spPr>
          <a:xfrm>
            <a:off x="186916" y="4650441"/>
            <a:ext cx="3856854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Tx/>
              <a:buChar char="-"/>
            </a:pPr>
            <a:r>
              <a:rPr lang="en-GB" sz="1400" dirty="0">
                <a:solidFill>
                  <a:srgbClr val="00437A"/>
                </a:solidFill>
              </a:rPr>
              <a:t>Sensitivity &amp; specificity of electronic health records compared to UK Renal Registry data</a:t>
            </a:r>
          </a:p>
          <a:p>
            <a:pPr marL="285750" indent="-285750">
              <a:buFontTx/>
              <a:buChar char="-"/>
            </a:pPr>
            <a:r>
              <a:rPr lang="en-GB" sz="1400" dirty="0">
                <a:solidFill>
                  <a:srgbClr val="00437A"/>
                </a:solidFill>
              </a:rPr>
              <a:t>Agreement between datasets (kappa statistic)</a:t>
            </a:r>
            <a:endParaRPr lang="en-GB" sz="1400" b="1" dirty="0">
              <a:solidFill>
                <a:srgbClr val="00437A"/>
              </a:solidFill>
            </a:endParaRPr>
          </a:p>
        </p:txBody>
      </p:sp>
      <p:grpSp>
        <p:nvGrpSpPr>
          <p:cNvPr id="10" name="Group 9">
            <a:extLst>
              <a:ext uri="{FF2B5EF4-FFF2-40B4-BE49-F238E27FC236}">
                <a16:creationId xmlns:a16="http://schemas.microsoft.com/office/drawing/2014/main" id="{54BE7682-88EA-F175-EE93-8A679443BB4A}"/>
              </a:ext>
            </a:extLst>
          </p:cNvPr>
          <p:cNvGrpSpPr/>
          <p:nvPr/>
        </p:nvGrpSpPr>
        <p:grpSpPr>
          <a:xfrm>
            <a:off x="524764" y="2804936"/>
            <a:ext cx="3167690" cy="1015144"/>
            <a:chOff x="515668" y="2912277"/>
            <a:chExt cx="3167690" cy="1015144"/>
          </a:xfrm>
        </p:grpSpPr>
        <p:pic>
          <p:nvPicPr>
            <p:cNvPr id="11" name="Graphic 10" descr="Laptop with solid fill">
              <a:extLst>
                <a:ext uri="{FF2B5EF4-FFF2-40B4-BE49-F238E27FC236}">
                  <a16:creationId xmlns:a16="http://schemas.microsoft.com/office/drawing/2014/main" id="{37D1DBE8-8E07-1877-C319-00315B2807E6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96DAC541-7B7A-43D3-8B79-37D633B846F1}">
                  <asvg:svgBlip xmlns:asvg="http://schemas.microsoft.com/office/drawing/2016/SVG/main" r:embed="rId5"/>
                </a:ext>
              </a:extLst>
            </a:blip>
            <a:stretch>
              <a:fillRect/>
            </a:stretch>
          </p:blipFill>
          <p:spPr>
            <a:xfrm>
              <a:off x="2668214" y="2912277"/>
              <a:ext cx="1015144" cy="1015144"/>
            </a:xfrm>
            <a:prstGeom prst="rect">
              <a:avLst/>
            </a:prstGeom>
          </p:spPr>
        </p:pic>
        <p:pic>
          <p:nvPicPr>
            <p:cNvPr id="12" name="Picture 11" descr="Logo&#10;&#10;Description automatically generated">
              <a:extLst>
                <a:ext uri="{FF2B5EF4-FFF2-40B4-BE49-F238E27FC236}">
                  <a16:creationId xmlns:a16="http://schemas.microsoft.com/office/drawing/2014/main" id="{8C4A5B67-16F5-F065-3110-E380D90F5FB3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515668" y="3048997"/>
              <a:ext cx="1521405" cy="728449"/>
            </a:xfrm>
            <a:prstGeom prst="rect">
              <a:avLst/>
            </a:prstGeom>
          </p:spPr>
        </p:pic>
        <p:cxnSp>
          <p:nvCxnSpPr>
            <p:cNvPr id="13" name="Straight Arrow Connector 12">
              <a:extLst>
                <a:ext uri="{FF2B5EF4-FFF2-40B4-BE49-F238E27FC236}">
                  <a16:creationId xmlns:a16="http://schemas.microsoft.com/office/drawing/2014/main" id="{BDFA5458-B879-4927-E389-7BA32C780BC5}"/>
                </a:ext>
              </a:extLst>
            </p:cNvPr>
            <p:cNvCxnSpPr>
              <a:cxnSpLocks/>
            </p:cNvCxnSpPr>
            <p:nvPr/>
          </p:nvCxnSpPr>
          <p:spPr>
            <a:xfrm>
              <a:off x="2116852" y="3494496"/>
              <a:ext cx="551362" cy="0"/>
            </a:xfrm>
            <a:prstGeom prst="straightConnector1">
              <a:avLst/>
            </a:prstGeom>
            <a:ln w="38100">
              <a:solidFill>
                <a:schemeClr val="accent5">
                  <a:lumMod val="75000"/>
                </a:schemeClr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4" name="TextBox 13">
            <a:extLst>
              <a:ext uri="{FF2B5EF4-FFF2-40B4-BE49-F238E27FC236}">
                <a16:creationId xmlns:a16="http://schemas.microsoft.com/office/drawing/2014/main" id="{8C766A60-D5A6-DC84-9034-44AEC648A57E}"/>
              </a:ext>
            </a:extLst>
          </p:cNvPr>
          <p:cNvSpPr txBox="1"/>
          <p:nvPr/>
        </p:nvSpPr>
        <p:spPr>
          <a:xfrm>
            <a:off x="4580352" y="1758951"/>
            <a:ext cx="12865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spc="-5" dirty="0">
                <a:solidFill>
                  <a:srgbClr val="004277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RESULTS</a:t>
            </a:r>
            <a:r>
              <a:rPr lang="en-GB" b="1" spc="-5" dirty="0">
                <a:solidFill>
                  <a:srgbClr val="004277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:</a:t>
            </a:r>
            <a:endParaRPr lang="en-US" b="1" dirty="0">
              <a:solidFill>
                <a:srgbClr val="004277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D7203274-0280-7C3F-E4B4-2CC2C443F4E1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86561" y="2099683"/>
            <a:ext cx="3479569" cy="2593526"/>
          </a:xfrm>
          <a:prstGeom prst="rect">
            <a:avLst/>
          </a:prstGeom>
          <a:noFill/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D2A24C84-B82E-8EFD-A389-AFA70F4578CF}"/>
              </a:ext>
            </a:extLst>
          </p:cNvPr>
          <p:cNvSpPr txBox="1"/>
          <p:nvPr/>
        </p:nvSpPr>
        <p:spPr>
          <a:xfrm>
            <a:off x="9366385" y="1757854"/>
            <a:ext cx="2797334" cy="116955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GB" sz="1400" b="1" dirty="0">
                <a:solidFill>
                  <a:srgbClr val="00437A"/>
                </a:solidFill>
              </a:rPr>
              <a:t>Agreement </a:t>
            </a:r>
          </a:p>
          <a:p>
            <a:pPr algn="ctr"/>
            <a:r>
              <a:rPr lang="en-GB" sz="1400" dirty="0">
                <a:solidFill>
                  <a:srgbClr val="00437A"/>
                </a:solidFill>
              </a:rPr>
              <a:t>Overall: Fair-to-moderate</a:t>
            </a:r>
          </a:p>
          <a:p>
            <a:pPr algn="ctr"/>
            <a:r>
              <a:rPr lang="en-GB" sz="1400" dirty="0">
                <a:solidFill>
                  <a:srgbClr val="00437A"/>
                </a:solidFill>
              </a:rPr>
              <a:t>Highest: Liver disease, prematurity &amp; malignancy</a:t>
            </a:r>
          </a:p>
          <a:p>
            <a:pPr algn="ctr"/>
            <a:r>
              <a:rPr lang="en-GB" sz="1400" dirty="0">
                <a:solidFill>
                  <a:srgbClr val="00437A"/>
                </a:solidFill>
              </a:rPr>
              <a:t>(kappa 0.49–0.52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D23BF415-9E21-BF56-6FBC-4073E04109A9}"/>
              </a:ext>
            </a:extLst>
          </p:cNvPr>
          <p:cNvSpPr txBox="1"/>
          <p:nvPr/>
        </p:nvSpPr>
        <p:spPr>
          <a:xfrm>
            <a:off x="9356325" y="3140801"/>
            <a:ext cx="2797334" cy="116955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GB" sz="1400" b="1" dirty="0">
                <a:solidFill>
                  <a:srgbClr val="00437A"/>
                </a:solidFill>
              </a:rPr>
              <a:t>Sensitivity</a:t>
            </a:r>
          </a:p>
          <a:p>
            <a:pPr algn="ctr"/>
            <a:r>
              <a:rPr lang="en-GB" sz="1400" dirty="0">
                <a:solidFill>
                  <a:srgbClr val="00437A"/>
                </a:solidFill>
              </a:rPr>
              <a:t>Highest: Congenital heart disease (0.65, 95% CI 0.51, 0.78)</a:t>
            </a:r>
          </a:p>
          <a:p>
            <a:pPr algn="ctr"/>
            <a:r>
              <a:rPr lang="en-GB" sz="1400" dirty="0">
                <a:solidFill>
                  <a:srgbClr val="00437A"/>
                </a:solidFill>
              </a:rPr>
              <a:t>Lowest: Diabetes </a:t>
            </a:r>
          </a:p>
          <a:p>
            <a:pPr algn="ctr"/>
            <a:r>
              <a:rPr lang="en-GB" sz="1400" dirty="0">
                <a:solidFill>
                  <a:srgbClr val="00437A"/>
                </a:solidFill>
              </a:rPr>
              <a:t>(0.00, 95% CI 0.00, 0.00)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19B18D98-FD43-9EFF-8240-B2C754B7E66C}"/>
              </a:ext>
            </a:extLst>
          </p:cNvPr>
          <p:cNvSpPr txBox="1"/>
          <p:nvPr/>
        </p:nvSpPr>
        <p:spPr>
          <a:xfrm>
            <a:off x="5528095" y="1791906"/>
            <a:ext cx="2646727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400" dirty="0">
                <a:solidFill>
                  <a:srgbClr val="00437A"/>
                </a:solidFill>
              </a:rPr>
              <a:t>890 children included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D8EF2481-4387-7AA2-B43A-EBF97A949A27}"/>
              </a:ext>
            </a:extLst>
          </p:cNvPr>
          <p:cNvSpPr txBox="1"/>
          <p:nvPr/>
        </p:nvSpPr>
        <p:spPr>
          <a:xfrm>
            <a:off x="6186090" y="4604912"/>
            <a:ext cx="428786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400" dirty="0">
                <a:solidFill>
                  <a:srgbClr val="00437A"/>
                </a:solidFill>
              </a:rPr>
              <a:t>Factors associated with likelihood of coding:</a:t>
            </a:r>
            <a:endParaRPr lang="en-GB" sz="1400" dirty="0">
              <a:solidFill>
                <a:srgbClr val="00437A"/>
              </a:solidFill>
            </a:endParaRPr>
          </a:p>
        </p:txBody>
      </p:sp>
      <p:grpSp>
        <p:nvGrpSpPr>
          <p:cNvPr id="20" name="Group 19">
            <a:extLst>
              <a:ext uri="{FF2B5EF4-FFF2-40B4-BE49-F238E27FC236}">
                <a16:creationId xmlns:a16="http://schemas.microsoft.com/office/drawing/2014/main" id="{010AC855-2E64-1763-D761-DF5C0E33B8EF}"/>
              </a:ext>
            </a:extLst>
          </p:cNvPr>
          <p:cNvGrpSpPr/>
          <p:nvPr/>
        </p:nvGrpSpPr>
        <p:grpSpPr>
          <a:xfrm>
            <a:off x="6544461" y="4903519"/>
            <a:ext cx="5755668" cy="617517"/>
            <a:chOff x="4935394" y="4896169"/>
            <a:chExt cx="5755668" cy="617517"/>
          </a:xfrm>
        </p:grpSpPr>
        <p:pic>
          <p:nvPicPr>
            <p:cNvPr id="21" name="Graphic 20" descr="Cake with solid fill">
              <a:extLst>
                <a:ext uri="{FF2B5EF4-FFF2-40B4-BE49-F238E27FC236}">
                  <a16:creationId xmlns:a16="http://schemas.microsoft.com/office/drawing/2014/main" id="{5CB3AA2F-DD32-7CE8-0C8B-1B68D27B6E43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9"/>
                </a:ext>
              </a:extLst>
            </a:blip>
            <a:stretch>
              <a:fillRect/>
            </a:stretch>
          </p:blipFill>
          <p:spPr>
            <a:xfrm>
              <a:off x="4935394" y="4921838"/>
              <a:ext cx="585671" cy="585671"/>
            </a:xfrm>
            <a:prstGeom prst="rect">
              <a:avLst/>
            </a:prstGeom>
          </p:spPr>
        </p:pic>
        <p:pic>
          <p:nvPicPr>
            <p:cNvPr id="22" name="Graphic 21" descr="Medicine with solid fill">
              <a:extLst>
                <a:ext uri="{FF2B5EF4-FFF2-40B4-BE49-F238E27FC236}">
                  <a16:creationId xmlns:a16="http://schemas.microsoft.com/office/drawing/2014/main" id="{A664DD38-C019-49A8-83DF-C3B4AEB9FADA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11"/>
                </a:ext>
              </a:extLst>
            </a:blip>
            <a:stretch>
              <a:fillRect/>
            </a:stretch>
          </p:blipFill>
          <p:spPr>
            <a:xfrm>
              <a:off x="7731915" y="4928014"/>
              <a:ext cx="585672" cy="585672"/>
            </a:xfrm>
            <a:prstGeom prst="rect">
              <a:avLst/>
            </a:prstGeom>
          </p:spPr>
        </p:pic>
        <p:pic>
          <p:nvPicPr>
            <p:cNvPr id="23" name="Graphic 22" descr="Kidneys with solid fill">
              <a:extLst>
                <a:ext uri="{FF2B5EF4-FFF2-40B4-BE49-F238E27FC236}">
                  <a16:creationId xmlns:a16="http://schemas.microsoft.com/office/drawing/2014/main" id="{26B1390D-77F0-5261-95C8-C70A3D1EA276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13"/>
                </a:ext>
              </a:extLst>
            </a:blip>
            <a:stretch>
              <a:fillRect/>
            </a:stretch>
          </p:blipFill>
          <p:spPr>
            <a:xfrm>
              <a:off x="6247886" y="4918400"/>
              <a:ext cx="585671" cy="585671"/>
            </a:xfrm>
            <a:prstGeom prst="rect">
              <a:avLst/>
            </a:prstGeom>
          </p:spPr>
        </p:pic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6EBFD725-0F45-1390-870F-EC11F4DA0392}"/>
                </a:ext>
              </a:extLst>
            </p:cNvPr>
            <p:cNvSpPr txBox="1"/>
            <p:nvPr/>
          </p:nvSpPr>
          <p:spPr>
            <a:xfrm>
              <a:off x="5457275" y="4990747"/>
              <a:ext cx="854401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solidFill>
                    <a:srgbClr val="00437A"/>
                  </a:solidFill>
                </a:rPr>
                <a:t>Older age at KRT start</a:t>
              </a:r>
              <a:endParaRPr lang="en-GB" sz="1100" dirty="0">
                <a:solidFill>
                  <a:srgbClr val="00437A"/>
                </a:solidFill>
              </a:endParaRP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8EE3F690-BF98-3CBA-639A-86A97414EA88}"/>
                </a:ext>
              </a:extLst>
            </p:cNvPr>
            <p:cNvSpPr txBox="1"/>
            <p:nvPr/>
          </p:nvSpPr>
          <p:spPr>
            <a:xfrm>
              <a:off x="6769767" y="4990747"/>
              <a:ext cx="1025938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solidFill>
                    <a:srgbClr val="00437A"/>
                  </a:solidFill>
                </a:rPr>
                <a:t>Primary Kidney disease</a:t>
              </a:r>
              <a:endParaRPr lang="en-GB" sz="1100" dirty="0">
                <a:solidFill>
                  <a:srgbClr val="00437A"/>
                </a:solidFill>
              </a:endParaRP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5DECD69D-9E31-277B-E1DA-972D0A0A1037}"/>
                </a:ext>
              </a:extLst>
            </p:cNvPr>
            <p:cNvSpPr txBox="1"/>
            <p:nvPr/>
          </p:nvSpPr>
          <p:spPr>
            <a:xfrm>
              <a:off x="8253797" y="4975204"/>
              <a:ext cx="1025938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solidFill>
                    <a:srgbClr val="00437A"/>
                  </a:solidFill>
                </a:rPr>
                <a:t>Number of comorbidities</a:t>
              </a:r>
              <a:endParaRPr lang="en-GB" sz="1100" dirty="0">
                <a:solidFill>
                  <a:srgbClr val="00437A"/>
                </a:solidFill>
              </a:endParaRPr>
            </a:p>
          </p:txBody>
        </p:sp>
        <p:pic>
          <p:nvPicPr>
            <p:cNvPr id="32" name="Graphic 31" descr="Earth globe: Africa and Europe with solid fill">
              <a:extLst>
                <a:ext uri="{FF2B5EF4-FFF2-40B4-BE49-F238E27FC236}">
                  <a16:creationId xmlns:a16="http://schemas.microsoft.com/office/drawing/2014/main" id="{1F280006-3F5A-5871-A5CC-10233442D707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15"/>
                </a:ext>
              </a:extLst>
            </a:blip>
            <a:stretch>
              <a:fillRect/>
            </a:stretch>
          </p:blipFill>
          <p:spPr>
            <a:xfrm>
              <a:off x="9215945" y="4896169"/>
              <a:ext cx="585671" cy="585671"/>
            </a:xfrm>
            <a:prstGeom prst="rect">
              <a:avLst/>
            </a:prstGeom>
          </p:spPr>
        </p:pic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B6E9F60C-4A08-5CB0-9919-D4FA68A1D2A8}"/>
                </a:ext>
              </a:extLst>
            </p:cNvPr>
            <p:cNvSpPr txBox="1"/>
            <p:nvPr/>
          </p:nvSpPr>
          <p:spPr>
            <a:xfrm>
              <a:off x="9665124" y="5058199"/>
              <a:ext cx="102593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solidFill>
                    <a:srgbClr val="00437A"/>
                  </a:solidFill>
                </a:rPr>
                <a:t>Country</a:t>
              </a:r>
              <a:endParaRPr lang="en-GB" sz="1100" dirty="0">
                <a:solidFill>
                  <a:srgbClr val="00437A"/>
                </a:solidFill>
              </a:endParaRPr>
            </a:p>
          </p:txBody>
        </p:sp>
      </p:grpSp>
      <p:pic>
        <p:nvPicPr>
          <p:cNvPr id="34" name="Graphic 33" descr="Handshake with solid fill">
            <a:extLst>
              <a:ext uri="{FF2B5EF4-FFF2-40B4-BE49-F238E27FC236}">
                <a16:creationId xmlns:a16="http://schemas.microsoft.com/office/drawing/2014/main" id="{00195409-A70E-E5BC-4A64-AA23C98F8D71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7"/>
              </a:ext>
            </a:extLst>
          </a:blip>
          <a:stretch>
            <a:fillRect/>
          </a:stretch>
        </p:blipFill>
        <p:spPr>
          <a:xfrm>
            <a:off x="8484109" y="1791906"/>
            <a:ext cx="914400" cy="914400"/>
          </a:xfrm>
          <a:prstGeom prst="rect">
            <a:avLst/>
          </a:prstGeom>
        </p:spPr>
      </p:pic>
      <p:pic>
        <p:nvPicPr>
          <p:cNvPr id="35" name="Graphic 34" descr="Target with solid fill">
            <a:extLst>
              <a:ext uri="{FF2B5EF4-FFF2-40B4-BE49-F238E27FC236}">
                <a16:creationId xmlns:a16="http://schemas.microsoft.com/office/drawing/2014/main" id="{0FCEA433-ADD5-B76D-DA10-C46A37C9E0B7}"/>
              </a:ext>
            </a:extLst>
          </p:cNvPr>
          <p:cNvPicPr>
            <a:picLocks noChangeAspect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19"/>
              </a:ext>
            </a:extLst>
          </a:blip>
          <a:stretch>
            <a:fillRect/>
          </a:stretch>
        </p:blipFill>
        <p:spPr>
          <a:xfrm>
            <a:off x="8506068" y="3085656"/>
            <a:ext cx="841765" cy="84176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057</TotalTime>
  <Words>221</Words>
  <Application>Microsoft Office PowerPoint</Application>
  <PresentationFormat>Widescreen</PresentationFormat>
  <Paragraphs>2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Laycock, Joseph</cp:lastModifiedBy>
  <cp:revision>60</cp:revision>
  <dcterms:created xsi:type="dcterms:W3CDTF">2019-06-13T12:30:18Z</dcterms:created>
  <dcterms:modified xsi:type="dcterms:W3CDTF">2024-07-17T10:57:41Z</dcterms:modified>
</cp:coreProperties>
</file>